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09728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34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9AE"/>
    <a:srgbClr val="FFFF66"/>
    <a:srgbClr val="FF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5" d="100"/>
          <a:sy n="95" d="100"/>
        </p:scale>
        <p:origin x="-112" y="-1224"/>
      </p:cViewPr>
      <p:guideLst>
        <p:guide orient="horz" pos="2880"/>
        <p:guide pos="34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204D5F-EC90-2041-985E-5C57D22B53ED}" type="datetimeFigureOut">
              <a:rPr lang="en-US" smtClean="0"/>
              <a:t>9/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685800"/>
            <a:ext cx="41148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F708FE-C168-0948-8478-CDC7D1F67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594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685800"/>
            <a:ext cx="41148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baseline="0" dirty="0" smtClean="0">
              <a:solidFill>
                <a:srgbClr val="FF0000"/>
              </a:solidFill>
              <a:latin typeface="+mn-lt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3A6A4E-3EA1-5348-BC8E-B0DFCF2E802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9883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840569"/>
            <a:ext cx="932688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45920" y="5181600"/>
            <a:ext cx="768096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122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666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5280" y="366188"/>
            <a:ext cx="246888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8640" y="366188"/>
            <a:ext cx="722376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2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33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776" y="5875869"/>
            <a:ext cx="932688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776" y="3875620"/>
            <a:ext cx="932688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804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8640" y="2133604"/>
            <a:ext cx="484632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7840" y="2133604"/>
            <a:ext cx="484632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898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1" y="2046817"/>
            <a:ext cx="484822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641" y="2899833"/>
            <a:ext cx="4848226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4033" y="2046817"/>
            <a:ext cx="4850130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4033" y="2899833"/>
            <a:ext cx="4850130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64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726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255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1" y="364067"/>
            <a:ext cx="3609976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90060" y="364071"/>
            <a:ext cx="6134101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641" y="1913471"/>
            <a:ext cx="3609976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71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50746" y="6400802"/>
            <a:ext cx="658368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50746" y="817033"/>
            <a:ext cx="658368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50746" y="7156453"/>
            <a:ext cx="658368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450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8640" y="366184"/>
            <a:ext cx="987552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2133604"/>
            <a:ext cx="987552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8640" y="8475138"/>
            <a:ext cx="25603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42B99-BBF8-724C-B107-8A18A2AC9BCA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49040" y="8475138"/>
            <a:ext cx="34747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63840" y="8475138"/>
            <a:ext cx="25603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95D4F-7D99-2A49-841C-A7474FD73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9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06172" y="36349"/>
            <a:ext cx="10115093" cy="8476235"/>
            <a:chOff x="378351" y="373975"/>
            <a:chExt cx="10115092" cy="8476235"/>
          </a:xfrm>
        </p:grpSpPr>
        <p:sp>
          <p:nvSpPr>
            <p:cNvPr id="36" name="Rectangle 35"/>
            <p:cNvSpPr/>
            <p:nvPr/>
          </p:nvSpPr>
          <p:spPr>
            <a:xfrm>
              <a:off x="2211506" y="2576907"/>
              <a:ext cx="1588795" cy="500218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/>
            </a:bodyPr>
            <a:lstStyle/>
            <a:p>
              <a:pPr algn="ctr"/>
              <a:r>
                <a:rPr lang="en-US" sz="1500" b="1" dirty="0" err="1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Cuffcompare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4685607" y="2576907"/>
              <a:ext cx="1428402" cy="500217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/>
            </a:bodyPr>
            <a:lstStyle/>
            <a:p>
              <a:pPr algn="ctr"/>
              <a:r>
                <a:rPr lang="en-US" sz="1500" b="1" dirty="0" err="1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Cuffmerge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4623467" y="4034581"/>
              <a:ext cx="1556833" cy="500410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Cuffdiff2</a:t>
              </a:r>
              <a:endParaRPr lang="en-US" sz="1500" b="1" baseline="30000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4606408" y="3268969"/>
              <a:ext cx="1598461" cy="571747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Merged Assemblies (GTF)</a:t>
              </a: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5258220" y="6658473"/>
              <a:ext cx="1559727" cy="565812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K-means Clustering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46" name="Rectangle 45"/>
            <p:cNvSpPr/>
            <p:nvPr/>
          </p:nvSpPr>
          <p:spPr>
            <a:xfrm>
              <a:off x="3228956" y="6658475"/>
              <a:ext cx="1714393" cy="578780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Transcript</a:t>
              </a:r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 </a:t>
              </a:r>
              <a:r>
                <a:rPr lang="en-US" sz="1500" b="1" dirty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clusters (25)</a:t>
              </a: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036624" y="4761433"/>
              <a:ext cx="2768992" cy="559132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Differential expression analysis at transcript level</a:t>
              </a: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3204294" y="7403348"/>
              <a:ext cx="1741291" cy="591053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Super-clusters (6)</a:t>
              </a:r>
            </a:p>
          </p:txBody>
        </p:sp>
        <p:cxnSp>
          <p:nvCxnSpPr>
            <p:cNvPr id="53" name="Straight Arrow Connector 52"/>
            <p:cNvCxnSpPr>
              <a:stCxn id="55" idx="1"/>
              <a:endCxn id="73" idx="3"/>
            </p:cNvCxnSpPr>
            <p:nvPr/>
          </p:nvCxnSpPr>
          <p:spPr>
            <a:xfrm flipH="1">
              <a:off x="4922751" y="8495679"/>
              <a:ext cx="391728" cy="1232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Elbow Connector 58"/>
            <p:cNvCxnSpPr>
              <a:stCxn id="36" idx="2"/>
              <a:endCxn id="41" idx="0"/>
            </p:cNvCxnSpPr>
            <p:nvPr/>
          </p:nvCxnSpPr>
          <p:spPr>
            <a:xfrm rot="5400000">
              <a:off x="2389581" y="2707016"/>
              <a:ext cx="246215" cy="986432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Elbow Connector 58"/>
            <p:cNvCxnSpPr>
              <a:stCxn id="37" idx="2"/>
              <a:endCxn id="40" idx="0"/>
            </p:cNvCxnSpPr>
            <p:nvPr/>
          </p:nvCxnSpPr>
          <p:spPr>
            <a:xfrm rot="16200000" flipH="1">
              <a:off x="5306801" y="3170130"/>
              <a:ext cx="191845" cy="5831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Elbow Connector 58"/>
            <p:cNvCxnSpPr>
              <a:stCxn id="49" idx="3"/>
              <a:endCxn id="39" idx="3"/>
            </p:cNvCxnSpPr>
            <p:nvPr/>
          </p:nvCxnSpPr>
          <p:spPr>
            <a:xfrm>
              <a:off x="5055413" y="1343651"/>
              <a:ext cx="1124887" cy="2941135"/>
            </a:xfrm>
            <a:prstGeom prst="bentConnector3">
              <a:avLst>
                <a:gd name="adj1" fmla="val 120322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Elbow Connector 58"/>
            <p:cNvCxnSpPr>
              <a:stCxn id="39" idx="2"/>
              <a:endCxn id="47" idx="0"/>
            </p:cNvCxnSpPr>
            <p:nvPr/>
          </p:nvCxnSpPr>
          <p:spPr>
            <a:xfrm rot="16200000" flipH="1">
              <a:off x="5298281" y="4638594"/>
              <a:ext cx="226442" cy="19236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Elbow Connector 58"/>
            <p:cNvCxnSpPr>
              <a:stCxn id="40" idx="2"/>
              <a:endCxn id="39" idx="0"/>
            </p:cNvCxnSpPr>
            <p:nvPr/>
          </p:nvCxnSpPr>
          <p:spPr>
            <a:xfrm rot="5400000">
              <a:off x="5306830" y="3935771"/>
              <a:ext cx="193865" cy="3755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Elbow Connector 58"/>
            <p:cNvCxnSpPr>
              <a:stCxn id="44" idx="1"/>
              <a:endCxn id="46" idx="3"/>
            </p:cNvCxnSpPr>
            <p:nvPr/>
          </p:nvCxnSpPr>
          <p:spPr>
            <a:xfrm rot="10800000" flipV="1">
              <a:off x="4943350" y="6941379"/>
              <a:ext cx="314871" cy="6486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Elbow Connector 58"/>
            <p:cNvCxnSpPr>
              <a:stCxn id="47" idx="2"/>
              <a:endCxn id="72" idx="0"/>
            </p:cNvCxnSpPr>
            <p:nvPr/>
          </p:nvCxnSpPr>
          <p:spPr>
            <a:xfrm rot="16200000" flipH="1">
              <a:off x="5575399" y="5166286"/>
              <a:ext cx="300631" cy="609188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2" name="Group 201"/>
            <p:cNvGrpSpPr/>
            <p:nvPr/>
          </p:nvGrpSpPr>
          <p:grpSpPr>
            <a:xfrm>
              <a:off x="378351" y="3323340"/>
              <a:ext cx="3282857" cy="3254625"/>
              <a:chOff x="309688" y="2575723"/>
              <a:chExt cx="2735714" cy="2440969"/>
            </a:xfrm>
            <a:solidFill>
              <a:srgbClr val="FFF9AE"/>
            </a:solidFill>
          </p:grpSpPr>
          <p:sp>
            <p:nvSpPr>
              <p:cNvPr id="41" name="Rectangle 40"/>
              <p:cNvSpPr/>
              <p:nvPr/>
            </p:nvSpPr>
            <p:spPr>
              <a:xfrm>
                <a:off x="309688" y="2575723"/>
                <a:ext cx="2735201" cy="422461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rgbClr val="000000"/>
                    </a:solidFill>
                    <a:latin typeface="+mj-lt"/>
                    <a:cs typeface="Arial" pitchFamily="34" charset="0"/>
                  </a:rPr>
                  <a:t>Mapped to known transcripts (‘=’)</a:t>
                </a: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309688" y="3065243"/>
                <a:ext cx="2735201" cy="411892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rgbClr val="000000"/>
                    </a:solidFill>
                    <a:latin typeface="+mj-lt"/>
                    <a:cs typeface="Arial" pitchFamily="34" charset="0"/>
                  </a:rPr>
                  <a:t>Novel isoforms of known genes (‘j’)</a:t>
                </a: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316903" y="3549195"/>
                <a:ext cx="2727986" cy="484981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rgbClr val="000000"/>
                    </a:solidFill>
                    <a:latin typeface="+mj-lt"/>
                    <a:cs typeface="Arial" pitchFamily="34" charset="0"/>
                  </a:rPr>
                  <a:t>Exon skipping (highly contained (‘c’), partial contained (‘o’))</a:t>
                </a: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316903" y="4106658"/>
                <a:ext cx="2728499" cy="479949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rgbClr val="000000"/>
                    </a:solidFill>
                    <a:latin typeface="+mj-lt"/>
                    <a:cs typeface="Arial" pitchFamily="34" charset="0"/>
                  </a:rPr>
                  <a:t>Antisense exons (‘x’), antisense introns (‘s’)</a:t>
                </a: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309688" y="4657302"/>
                <a:ext cx="2727986" cy="359390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>
                <a:normAutofit/>
              </a:bodyPr>
              <a:lstStyle/>
              <a:p>
                <a:pPr algn="ctr"/>
                <a:r>
                  <a:rPr lang="en-US" sz="1500" b="1" dirty="0" err="1" smtClean="0">
                    <a:solidFill>
                      <a:srgbClr val="000000"/>
                    </a:solidFill>
                    <a:latin typeface="+mj-lt"/>
                    <a:cs typeface="Arial" pitchFamily="34" charset="0"/>
                  </a:rPr>
                  <a:t>Intergenic</a:t>
                </a:r>
                <a:r>
                  <a:rPr lang="en-US" sz="1500" b="1" dirty="0" smtClean="0">
                    <a:solidFill>
                      <a:srgbClr val="000000"/>
                    </a:solidFill>
                    <a:latin typeface="+mj-lt"/>
                    <a:cs typeface="Arial" pitchFamily="34" charset="0"/>
                  </a:rPr>
                  <a:t> Transcripts</a:t>
                </a:r>
              </a:p>
            </p:txBody>
          </p:sp>
        </p:grpSp>
        <p:sp>
          <p:nvSpPr>
            <p:cNvPr id="72" name="Rectangle 71"/>
            <p:cNvSpPr/>
            <p:nvPr/>
          </p:nvSpPr>
          <p:spPr>
            <a:xfrm>
              <a:off x="3967987" y="5621196"/>
              <a:ext cx="4124641" cy="741983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 lnSpcReduction="10000"/>
            </a:bodyPr>
            <a:lstStyle/>
            <a:p>
              <a:pPr algn="ctr"/>
              <a:r>
                <a:rPr lang="en-US" sz="1500" b="1" dirty="0" smtClean="0">
                  <a:solidFill>
                    <a:srgbClr val="000000"/>
                  </a:solidFill>
                  <a:latin typeface="Calibri"/>
                  <a:cs typeface="Calibri"/>
                </a:rPr>
                <a:t>Identification </a:t>
              </a:r>
              <a:r>
                <a:rPr lang="en-US" sz="1500" b="1" dirty="0">
                  <a:solidFill>
                    <a:srgbClr val="000000"/>
                  </a:solidFill>
                  <a:latin typeface="Calibri"/>
                  <a:cs typeface="Calibri"/>
                </a:rPr>
                <a:t>of </a:t>
              </a:r>
              <a:r>
                <a:rPr lang="en-US" sz="1500" b="1" dirty="0" smtClean="0">
                  <a:solidFill>
                    <a:srgbClr val="000000"/>
                  </a:solidFill>
                  <a:latin typeface="Calibri"/>
                  <a:cs typeface="Calibri"/>
                </a:rPr>
                <a:t>splice variants that </a:t>
              </a:r>
              <a:r>
                <a:rPr lang="en-US" sz="1500" b="1" dirty="0">
                  <a:solidFill>
                    <a:srgbClr val="000000"/>
                  </a:solidFill>
                  <a:latin typeface="Calibri"/>
                  <a:cs typeface="Calibri"/>
                </a:rPr>
                <a:t>changed significantly </a:t>
              </a:r>
              <a:r>
                <a:rPr lang="en-US" sz="1500" b="1" dirty="0" smtClean="0">
                  <a:solidFill>
                    <a:srgbClr val="000000"/>
                  </a:solidFill>
                  <a:latin typeface="Calibri"/>
                  <a:cs typeface="Calibri"/>
                </a:rPr>
                <a:t>at at least one time point compared with previous time point</a:t>
              </a:r>
              <a:endParaRPr lang="en-US" sz="1500" b="1" dirty="0">
                <a:solidFill>
                  <a:srgbClr val="000000"/>
                </a:solidFill>
                <a:latin typeface="Calibri"/>
                <a:cs typeface="Calibri"/>
              </a:endParaRPr>
            </a:p>
          </p:txBody>
        </p:sp>
        <p:cxnSp>
          <p:nvCxnSpPr>
            <p:cNvPr id="74" name="Elbow Connector 58"/>
            <p:cNvCxnSpPr>
              <a:stCxn id="72" idx="2"/>
              <a:endCxn id="44" idx="0"/>
            </p:cNvCxnSpPr>
            <p:nvPr/>
          </p:nvCxnSpPr>
          <p:spPr>
            <a:xfrm rot="16200000" flipH="1">
              <a:off x="5886549" y="6506938"/>
              <a:ext cx="295294" cy="7776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Rectangle 84"/>
            <p:cNvSpPr/>
            <p:nvPr/>
          </p:nvSpPr>
          <p:spPr>
            <a:xfrm>
              <a:off x="3459061" y="1805231"/>
              <a:ext cx="1596350" cy="447510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Cufflinks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3453234" y="1105315"/>
              <a:ext cx="1602179" cy="476671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rmAutofit/>
            </a:bodyPr>
            <a:lstStyle/>
            <a:p>
              <a:pPr algn="ctr"/>
              <a:r>
                <a:rPr lang="en-US" sz="1500" b="1" dirty="0" err="1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Tophat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5287907" y="7402889"/>
              <a:ext cx="1469758" cy="591512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Beacon Editor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7196894" y="7415219"/>
              <a:ext cx="1472033" cy="571025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Signaling Pathways</a:t>
              </a: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5314479" y="8153472"/>
              <a:ext cx="2296293" cy="684413"/>
            </a:xfrm>
            <a:prstGeom prst="rect">
              <a:avLst/>
            </a:prstGeom>
            <a:solidFill>
              <a:srgbClr val="FF0000">
                <a:alpha val="21961"/>
              </a:srgbClr>
            </a:solidFill>
            <a:ln w="190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Network Analysis: </a:t>
              </a:r>
              <a:r>
                <a:rPr lang="en-US" sz="1500" b="1" dirty="0" err="1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ArrayMining</a:t>
              </a:r>
              <a:r>
                <a:rPr lang="en-US" sz="1500" b="1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, Finding Hubs</a:t>
              </a:r>
              <a:endParaRPr lang="en-US" sz="1500" b="1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cxnSp>
          <p:nvCxnSpPr>
            <p:cNvPr id="112" name="Straight Arrow Connector 111"/>
            <p:cNvCxnSpPr>
              <a:stCxn id="46" idx="2"/>
              <a:endCxn id="52" idx="0"/>
            </p:cNvCxnSpPr>
            <p:nvPr/>
          </p:nvCxnSpPr>
          <p:spPr>
            <a:xfrm flipH="1">
              <a:off x="4074940" y="7237255"/>
              <a:ext cx="11213" cy="1660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Elbow Connector 58"/>
            <p:cNvCxnSpPr>
              <a:stCxn id="85" idx="2"/>
              <a:endCxn id="36" idx="0"/>
            </p:cNvCxnSpPr>
            <p:nvPr/>
          </p:nvCxnSpPr>
          <p:spPr>
            <a:xfrm rot="5400000">
              <a:off x="3469487" y="1789158"/>
              <a:ext cx="324166" cy="1251332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Elbow Connector 58"/>
            <p:cNvCxnSpPr>
              <a:stCxn id="85" idx="2"/>
              <a:endCxn id="37" idx="0"/>
            </p:cNvCxnSpPr>
            <p:nvPr/>
          </p:nvCxnSpPr>
          <p:spPr>
            <a:xfrm rot="16200000" flipH="1">
              <a:off x="4666439" y="1843538"/>
              <a:ext cx="324166" cy="1142572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Rectangle 195"/>
            <p:cNvSpPr/>
            <p:nvPr/>
          </p:nvSpPr>
          <p:spPr>
            <a:xfrm>
              <a:off x="6720672" y="1023824"/>
              <a:ext cx="1978866" cy="3569648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100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1000"/>
                  </a:schemeClr>
                </a:gs>
              </a:gsLst>
              <a:lin ang="16200000" scaled="0"/>
              <a:tileRect/>
            </a:gradFill>
            <a:ln w="19050" cmpd="sng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grpSp>
          <p:nvGrpSpPr>
            <p:cNvPr id="501" name="Group 500"/>
            <p:cNvGrpSpPr/>
            <p:nvPr/>
          </p:nvGrpSpPr>
          <p:grpSpPr>
            <a:xfrm>
              <a:off x="6845559" y="1105315"/>
              <a:ext cx="1687759" cy="3322893"/>
              <a:chOff x="7237084" y="1105315"/>
              <a:chExt cx="1687759" cy="3322893"/>
            </a:xfrm>
          </p:grpSpPr>
          <p:sp>
            <p:nvSpPr>
              <p:cNvPr id="189" name="Rectangle 188"/>
              <p:cNvSpPr/>
              <p:nvPr/>
            </p:nvSpPr>
            <p:spPr>
              <a:xfrm>
                <a:off x="7268020" y="1105315"/>
                <a:ext cx="1652653" cy="584444"/>
              </a:xfrm>
              <a:prstGeom prst="rect">
                <a:avLst/>
              </a:prstGeom>
              <a:solidFill>
                <a:srgbClr val="CCFFCC">
                  <a:alpha val="21961"/>
                </a:srgbClr>
              </a:solidFill>
              <a:ln w="19050" cmpd="sng"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Conserved Domains (CDD)</a:t>
                </a:r>
                <a:endParaRPr lang="en-US" sz="1500" b="1" baseline="300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0" name="Rectangle 189"/>
              <p:cNvSpPr/>
              <p:nvPr/>
            </p:nvSpPr>
            <p:spPr>
              <a:xfrm>
                <a:off x="7268020" y="3862199"/>
                <a:ext cx="1652653" cy="566009"/>
              </a:xfrm>
              <a:prstGeom prst="rect">
                <a:avLst/>
              </a:prstGeom>
              <a:solidFill>
                <a:srgbClr val="CCFFCC">
                  <a:alpha val="21961"/>
                </a:srgbClr>
              </a:solidFill>
              <a:ln w="19050" cmpd="sng"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Coding Potential Calculator (CPC)</a:t>
                </a:r>
                <a:endParaRPr lang="en-US" sz="1500" b="1" baseline="300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1" name="Rectangle 190"/>
              <p:cNvSpPr/>
              <p:nvPr/>
            </p:nvSpPr>
            <p:spPr>
              <a:xfrm>
                <a:off x="7237084" y="1793083"/>
                <a:ext cx="1652653" cy="584444"/>
              </a:xfrm>
              <a:prstGeom prst="rect">
                <a:avLst/>
              </a:prstGeom>
              <a:solidFill>
                <a:srgbClr val="CCFFCC">
                  <a:alpha val="21961"/>
                </a:srgbClr>
              </a:solidFill>
              <a:ln w="19050" cmpd="sng"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Mercator (</a:t>
                </a:r>
                <a:r>
                  <a:rPr lang="en-US" sz="1500" b="1" dirty="0" err="1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MapMan</a:t>
                </a:r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 bins)</a:t>
                </a:r>
                <a:endParaRPr lang="en-US" sz="1500" b="1" baseline="300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2" name="Rectangle 191"/>
              <p:cNvSpPr/>
              <p:nvPr/>
            </p:nvSpPr>
            <p:spPr>
              <a:xfrm>
                <a:off x="7268020" y="2507401"/>
                <a:ext cx="1652653" cy="547321"/>
              </a:xfrm>
              <a:prstGeom prst="rect">
                <a:avLst/>
              </a:prstGeom>
              <a:solidFill>
                <a:srgbClr val="CCFFCC">
                  <a:alpha val="21961"/>
                </a:srgbClr>
              </a:solidFill>
              <a:ln w="19050" cmpd="sng"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RNA 2</a:t>
                </a:r>
                <a:r>
                  <a:rPr lang="en-US" sz="1500" b="1" baseline="30000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o</a:t>
                </a:r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 structure</a:t>
                </a:r>
                <a:endParaRPr lang="en-US" sz="1500" b="1" baseline="300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93" name="Rectangle 192"/>
              <p:cNvSpPr/>
              <p:nvPr/>
            </p:nvSpPr>
            <p:spPr>
              <a:xfrm>
                <a:off x="7272190" y="3177229"/>
                <a:ext cx="1652653" cy="566009"/>
              </a:xfrm>
              <a:prstGeom prst="rect">
                <a:avLst/>
              </a:prstGeom>
              <a:solidFill>
                <a:srgbClr val="CCFFCC">
                  <a:alpha val="21961"/>
                </a:srgbClr>
              </a:solidFill>
              <a:ln w="19050" cmpd="sng">
                <a:solidFill>
                  <a:srgbClr val="008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US" sz="1500" b="1" dirty="0" smtClean="0">
                    <a:solidFill>
                      <a:schemeClr val="tx1"/>
                    </a:solidFill>
                    <a:latin typeface="+mj-lt"/>
                    <a:cs typeface="Arial" pitchFamily="34" charset="0"/>
                  </a:rPr>
                  <a:t>Sequence properties</a:t>
                </a:r>
                <a:endParaRPr lang="en-US" sz="1500" b="1" baseline="30000" dirty="0">
                  <a:solidFill>
                    <a:schemeClr val="tx1"/>
                  </a:solidFill>
                  <a:latin typeface="+mj-lt"/>
                  <a:cs typeface="Arial" pitchFamily="34" charset="0"/>
                </a:endParaRPr>
              </a:p>
            </p:txBody>
          </p:sp>
        </p:grpSp>
        <p:sp>
          <p:nvSpPr>
            <p:cNvPr id="194" name="Rectangle 193"/>
            <p:cNvSpPr/>
            <p:nvPr/>
          </p:nvSpPr>
          <p:spPr>
            <a:xfrm>
              <a:off x="9054411" y="2020542"/>
              <a:ext cx="1397111" cy="566009"/>
            </a:xfrm>
            <a:prstGeom prst="rect">
              <a:avLst/>
            </a:prstGeom>
            <a:solidFill>
              <a:srgbClr val="CCFFCC">
                <a:alpha val="21961"/>
              </a:srgbClr>
            </a:solidFill>
            <a:ln w="19050" cmpd="sng"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Support Vector Machine (SVM)</a:t>
              </a:r>
              <a:endParaRPr lang="en-US" sz="1500" b="1" baseline="30000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sp>
          <p:nvSpPr>
            <p:cNvPr id="198" name="Rectangle 197"/>
            <p:cNvSpPr/>
            <p:nvPr/>
          </p:nvSpPr>
          <p:spPr>
            <a:xfrm>
              <a:off x="9005087" y="2968574"/>
              <a:ext cx="1488356" cy="556768"/>
            </a:xfrm>
            <a:prstGeom prst="rect">
              <a:avLst/>
            </a:prstGeom>
            <a:solidFill>
              <a:srgbClr val="008000">
                <a:alpha val="57000"/>
              </a:srgbClr>
            </a:solidFill>
            <a:ln w="19050" cmpd="sng"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Functional Characterization</a:t>
              </a:r>
              <a:endParaRPr lang="en-US" sz="1500" b="1" baseline="30000" dirty="0">
                <a:solidFill>
                  <a:schemeClr val="tx1"/>
                </a:solidFill>
                <a:latin typeface="+mj-lt"/>
                <a:cs typeface="Arial" pitchFamily="34" charset="0"/>
              </a:endParaRPr>
            </a:p>
          </p:txBody>
        </p:sp>
        <p:cxnSp>
          <p:nvCxnSpPr>
            <p:cNvPr id="204" name="Straight Arrow Connector 203"/>
            <p:cNvCxnSpPr>
              <a:endCxn id="194" idx="1"/>
            </p:cNvCxnSpPr>
            <p:nvPr/>
          </p:nvCxnSpPr>
          <p:spPr>
            <a:xfrm>
              <a:off x="8785855" y="2294807"/>
              <a:ext cx="268556" cy="874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Arrow Connector 221"/>
            <p:cNvCxnSpPr>
              <a:stCxn id="40" idx="3"/>
            </p:cNvCxnSpPr>
            <p:nvPr/>
          </p:nvCxnSpPr>
          <p:spPr>
            <a:xfrm>
              <a:off x="6204869" y="3554843"/>
              <a:ext cx="55279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Elbow Connector 58"/>
            <p:cNvCxnSpPr>
              <a:stCxn id="198" idx="2"/>
              <a:endCxn id="44" idx="3"/>
            </p:cNvCxnSpPr>
            <p:nvPr/>
          </p:nvCxnSpPr>
          <p:spPr>
            <a:xfrm rot="5400000">
              <a:off x="6575588" y="3767701"/>
              <a:ext cx="3416037" cy="2931318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Elbow Connector 58"/>
            <p:cNvCxnSpPr>
              <a:stCxn id="52" idx="3"/>
              <a:endCxn id="68" idx="1"/>
            </p:cNvCxnSpPr>
            <p:nvPr/>
          </p:nvCxnSpPr>
          <p:spPr>
            <a:xfrm flipV="1">
              <a:off x="4945585" y="7698645"/>
              <a:ext cx="342322" cy="230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6" name="Elbow Connector 58"/>
            <p:cNvCxnSpPr>
              <a:endCxn id="39" idx="1"/>
            </p:cNvCxnSpPr>
            <p:nvPr/>
          </p:nvCxnSpPr>
          <p:spPr>
            <a:xfrm>
              <a:off x="3005905" y="3197638"/>
              <a:ext cx="1617562" cy="1087148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9" name="Rectangle 428"/>
            <p:cNvSpPr/>
            <p:nvPr/>
          </p:nvSpPr>
          <p:spPr>
            <a:xfrm>
              <a:off x="702852" y="1774178"/>
              <a:ext cx="2001889" cy="520631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Reference Genome (GTF/GFF)</a:t>
              </a:r>
            </a:p>
          </p:txBody>
        </p:sp>
        <p:cxnSp>
          <p:nvCxnSpPr>
            <p:cNvPr id="430" name="Elbow Connector 58"/>
            <p:cNvCxnSpPr>
              <a:stCxn id="429" idx="2"/>
              <a:endCxn id="36" idx="1"/>
            </p:cNvCxnSpPr>
            <p:nvPr/>
          </p:nvCxnSpPr>
          <p:spPr>
            <a:xfrm rot="16200000" flipH="1">
              <a:off x="1691548" y="2307057"/>
              <a:ext cx="532207" cy="507709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6" name="Straight Arrow Connector 435"/>
            <p:cNvCxnSpPr>
              <a:stCxn id="429" idx="3"/>
              <a:endCxn id="85" idx="1"/>
            </p:cNvCxnSpPr>
            <p:nvPr/>
          </p:nvCxnSpPr>
          <p:spPr>
            <a:xfrm flipV="1">
              <a:off x="2704741" y="2028986"/>
              <a:ext cx="754320" cy="550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0" name="Rectangle 459"/>
            <p:cNvSpPr/>
            <p:nvPr/>
          </p:nvSpPr>
          <p:spPr>
            <a:xfrm>
              <a:off x="3464988" y="373975"/>
              <a:ext cx="1601042" cy="521730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Reads</a:t>
              </a:r>
            </a:p>
          </p:txBody>
        </p:sp>
        <p:cxnSp>
          <p:nvCxnSpPr>
            <p:cNvPr id="477" name="Elbow Connector 58"/>
            <p:cNvCxnSpPr>
              <a:stCxn id="49" idx="2"/>
            </p:cNvCxnSpPr>
            <p:nvPr/>
          </p:nvCxnSpPr>
          <p:spPr>
            <a:xfrm rot="16200000" flipH="1">
              <a:off x="4120588" y="1715722"/>
              <a:ext cx="267475" cy="2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2" name="Elbow Connector 58"/>
            <p:cNvCxnSpPr>
              <a:stCxn id="460" idx="2"/>
              <a:endCxn id="49" idx="0"/>
            </p:cNvCxnSpPr>
            <p:nvPr/>
          </p:nvCxnSpPr>
          <p:spPr>
            <a:xfrm rot="5400000">
              <a:off x="4155112" y="994918"/>
              <a:ext cx="209610" cy="11185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8" name="Straight Arrow Connector 517"/>
            <p:cNvCxnSpPr>
              <a:endCxn id="198" idx="1"/>
            </p:cNvCxnSpPr>
            <p:nvPr/>
          </p:nvCxnSpPr>
          <p:spPr>
            <a:xfrm>
              <a:off x="8736531" y="3246958"/>
              <a:ext cx="26855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3" name="Straight Arrow Connector 522"/>
            <p:cNvCxnSpPr>
              <a:stCxn id="194" idx="2"/>
              <a:endCxn id="198" idx="0"/>
            </p:cNvCxnSpPr>
            <p:nvPr/>
          </p:nvCxnSpPr>
          <p:spPr>
            <a:xfrm flipH="1">
              <a:off x="9749265" y="2586551"/>
              <a:ext cx="3702" cy="3820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7" name="Straight Arrow Connector 526"/>
            <p:cNvCxnSpPr>
              <a:stCxn id="37" idx="1"/>
              <a:endCxn id="36" idx="3"/>
            </p:cNvCxnSpPr>
            <p:nvPr/>
          </p:nvCxnSpPr>
          <p:spPr>
            <a:xfrm flipH="1">
              <a:off x="3800301" y="2827016"/>
              <a:ext cx="88530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2" name="Straight Arrow Connector 531"/>
            <p:cNvCxnSpPr>
              <a:endCxn id="196" idx="2"/>
            </p:cNvCxnSpPr>
            <p:nvPr/>
          </p:nvCxnSpPr>
          <p:spPr>
            <a:xfrm flipV="1">
              <a:off x="7710105" y="4593472"/>
              <a:ext cx="0" cy="10277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Rectangle 72"/>
            <p:cNvSpPr/>
            <p:nvPr/>
          </p:nvSpPr>
          <p:spPr>
            <a:xfrm>
              <a:off x="2479815" y="8165798"/>
              <a:ext cx="2442936" cy="684412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algn="ctr"/>
              <a:r>
                <a:rPr lang="en-US" sz="1500" b="1" dirty="0" smtClean="0">
                  <a:solidFill>
                    <a:schemeClr val="tx1"/>
                  </a:solidFill>
                  <a:latin typeface="+mj-lt"/>
                  <a:cs typeface="Arial" pitchFamily="34" charset="0"/>
                </a:rPr>
                <a:t>Stage specific co-expression network of splice variants </a:t>
              </a:r>
            </a:p>
          </p:txBody>
        </p:sp>
        <p:cxnSp>
          <p:nvCxnSpPr>
            <p:cNvPr id="119" name="Elbow Connector 58"/>
            <p:cNvCxnSpPr>
              <a:stCxn id="68" idx="3"/>
              <a:endCxn id="45" idx="1"/>
            </p:cNvCxnSpPr>
            <p:nvPr/>
          </p:nvCxnSpPr>
          <p:spPr>
            <a:xfrm>
              <a:off x="6757664" y="7698645"/>
              <a:ext cx="439230" cy="2087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Elbow Connector 58"/>
            <p:cNvCxnSpPr>
              <a:stCxn id="45" idx="2"/>
              <a:endCxn id="55" idx="3"/>
            </p:cNvCxnSpPr>
            <p:nvPr/>
          </p:nvCxnSpPr>
          <p:spPr>
            <a:xfrm rot="5400000">
              <a:off x="7517124" y="8079891"/>
              <a:ext cx="509435" cy="322140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10394361" y="8555473"/>
            <a:ext cx="46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90525" y="8608169"/>
            <a:ext cx="996972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upplemental Figure </a:t>
            </a:r>
            <a:r>
              <a:rPr lang="en-US" sz="1400" dirty="0"/>
              <a:t>1</a:t>
            </a:r>
            <a:r>
              <a:rPr lang="en-US" sz="1400" dirty="0" smtClean="0"/>
              <a:t>. </a:t>
            </a:r>
            <a:r>
              <a:rPr lang="en-US" sz="1400" dirty="0" smtClean="0"/>
              <a:t>RNA-</a:t>
            </a:r>
            <a:r>
              <a:rPr lang="en-US" sz="1400" dirty="0" err="1"/>
              <a:t>S</a:t>
            </a:r>
            <a:r>
              <a:rPr lang="en-US" sz="1400" dirty="0" err="1" smtClean="0"/>
              <a:t>eq</a:t>
            </a:r>
            <a:r>
              <a:rPr lang="en-US" sz="1400" dirty="0" smtClean="0"/>
              <a:t> </a:t>
            </a:r>
            <a:r>
              <a:rPr lang="en-US" sz="1400" dirty="0"/>
              <a:t>data and other computational analyses pipeline. The tools are shown in red, classifier specific tools are in green, transcript classes are in yellow, and outputs are in white. </a:t>
            </a:r>
          </a:p>
        </p:txBody>
      </p:sp>
    </p:spTree>
    <p:extLst>
      <p:ext uri="{BB962C8B-B14F-4D97-AF65-F5344CB8AC3E}">
        <p14:creationId xmlns:p14="http://schemas.microsoft.com/office/powerpoint/2010/main" val="12061103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203</Words>
  <Application>Microsoft Macintosh PowerPoint</Application>
  <PresentationFormat>Custom</PresentationFormat>
  <Paragraphs>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irginia Te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ools Used in RNA-Seq Analysis Pipeline</dc:title>
  <dc:creator>Delasa Aghamirzaie</dc:creator>
  <cp:lastModifiedBy>Delasa Aghamirzaie</cp:lastModifiedBy>
  <cp:revision>28</cp:revision>
  <dcterms:created xsi:type="dcterms:W3CDTF">2014-10-10T16:20:50Z</dcterms:created>
  <dcterms:modified xsi:type="dcterms:W3CDTF">2015-09-09T18:05:05Z</dcterms:modified>
</cp:coreProperties>
</file>